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5"/>
  </p:notesMasterIdLst>
  <p:sldIdLst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78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8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F92357-2328-4E8A-A250-59677EF46B9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B0D5DC-6DD5-4526-B9C9-7ED418538D7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121725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</a:t>
            </a:r>
            <a:r>
              <a:rPr lang="en-CA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CA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dentification of cell fusion in human MSC, rat </a:t>
            </a:r>
            <a:r>
              <a:rPr lang="en-CA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rdiomyocyte</a:t>
            </a:r>
            <a:r>
              <a:rPr lang="en-CA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-cultures</a:t>
            </a:r>
            <a:r>
              <a:rPr lang="en-CA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CA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FC and FACS gating of human MSC from rat </a:t>
            </a:r>
            <a:r>
              <a:rPr lang="en-CA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rdiomyocyte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-cultures. Anti-TRA-1-85 APC or FITC conjugated antibodies applied. TRA-1-85</a:t>
            </a:r>
            <a:r>
              <a:rPr lang="en-CA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TC (H) and TRA-1-85</a:t>
            </a:r>
            <a:r>
              <a:rPr lang="en-CA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C (H) populations considered to be human MSCs and further analysed or sorted. TRA-1-85</a:t>
            </a:r>
            <a:r>
              <a:rPr lang="en-CA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w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s (L) were also sorted for cell fusion analysis.</a:t>
            </a: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B20771-1F14-4FAB-B633-4F75DC8BCBDC}" type="slidenum">
              <a:rPr lang="en-CA" smtClean="0">
                <a:solidFill>
                  <a:prstClr val="black"/>
                </a:solidFill>
              </a:rPr>
              <a:pPr/>
              <a:t>1</a:t>
            </a:fld>
            <a:endParaRPr lang="en-CA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775728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-1-85</a:t>
            </a:r>
            <a:r>
              <a:rPr lang="en-CA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B) and low TRA-1-85</a:t>
            </a:r>
            <a:r>
              <a:rPr lang="en-CA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w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C) cells sorted from </a:t>
            </a:r>
            <a:r>
              <a:rPr lang="en-CA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MSC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rat </a:t>
            </a:r>
            <a:r>
              <a:rPr lang="en-CA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rdiomyocyte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-cultures and stained for human nuclear </a:t>
            </a:r>
            <a:r>
              <a:rPr lang="en-CA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igene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CA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uNu</a:t>
            </a:r>
            <a:r>
              <a:rPr lang="en-CA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red). Superimposed bright field, fluorescent microscopy images. Blue: Hoechst (DAPI) Bar=100µm</a:t>
            </a: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B20771-1F14-4FAB-B633-4F75DC8BCBDC}" type="slidenum">
              <a:rPr lang="en-CA" smtClean="0">
                <a:solidFill>
                  <a:prstClr val="black"/>
                </a:solidFill>
              </a:rPr>
              <a:pPr/>
              <a:t>2</a:t>
            </a:fld>
            <a:endParaRPr lang="en-CA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83817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00670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99735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359348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455897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0438040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734453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977322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94177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913199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16795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180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9257850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537889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323479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8778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7998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33938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90370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74242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13518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3395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94341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693C9-C4CB-4C9F-B346-74203CC3E3D1}" type="datetimeFigureOut">
              <a:rPr lang="en-CA" smtClean="0"/>
              <a:t>2016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AE87F-D19E-478A-B6FC-24888689BB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57305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959A68-DB96-4BBA-90F5-0457AF0E549E}" type="datetimeFigureOut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2016-02-12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20F1F-512D-41E1-A67D-B3BD14F425B2}" type="slidenum">
              <a:rPr lang="en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88861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3776" t="6783" b="7507"/>
          <a:stretch/>
        </p:blipFill>
        <p:spPr>
          <a:xfrm>
            <a:off x="2737728" y="3852613"/>
            <a:ext cx="2454308" cy="2152357"/>
          </a:xfrm>
          <a:prstGeom prst="rect">
            <a:avLst/>
          </a:prstGeom>
          <a:ln>
            <a:noFill/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/>
          <a:srcRect l="4325" t="6915" b="7695"/>
          <a:stretch/>
        </p:blipFill>
        <p:spPr>
          <a:xfrm>
            <a:off x="5253109" y="3866681"/>
            <a:ext cx="2497807" cy="2138289"/>
          </a:xfrm>
          <a:prstGeom prst="rect">
            <a:avLst/>
          </a:prstGeom>
          <a:ln>
            <a:noFill/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5"/>
          <a:srcRect l="4505" t="7153" b="7368"/>
          <a:stretch/>
        </p:blipFill>
        <p:spPr>
          <a:xfrm>
            <a:off x="7811989" y="3866681"/>
            <a:ext cx="2482915" cy="2138289"/>
          </a:xfrm>
          <a:prstGeom prst="rect">
            <a:avLst/>
          </a:prstGeom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181732" y="4312381"/>
            <a:ext cx="20185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dirty="0">
                <a:solidFill>
                  <a:prstClr val="black"/>
                </a:solidFill>
              </a:rPr>
              <a:t>FTM-PVC, </a:t>
            </a:r>
          </a:p>
          <a:p>
            <a:pPr algn="r"/>
            <a:r>
              <a:rPr lang="en-CA" dirty="0">
                <a:solidFill>
                  <a:prstClr val="black"/>
                </a:solidFill>
              </a:rPr>
              <a:t>rat </a:t>
            </a:r>
            <a:r>
              <a:rPr lang="en-CA" dirty="0" err="1">
                <a:solidFill>
                  <a:prstClr val="black"/>
                </a:solidFill>
              </a:rPr>
              <a:t>cardiomyocyte</a:t>
            </a:r>
            <a:r>
              <a:rPr lang="en-CA" dirty="0">
                <a:solidFill>
                  <a:prstClr val="black"/>
                </a:solidFill>
              </a:rPr>
              <a:t> </a:t>
            </a:r>
          </a:p>
          <a:p>
            <a:pPr algn="r"/>
            <a:r>
              <a:rPr lang="en-CA" dirty="0">
                <a:solidFill>
                  <a:prstClr val="black"/>
                </a:solidFill>
              </a:rPr>
              <a:t>co-culture</a:t>
            </a:r>
            <a:endParaRPr lang="en-CA" dirty="0">
              <a:solidFill>
                <a:prstClr val="black"/>
              </a:solidFill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6"/>
          <a:srcRect l="4881" t="6930" b="7600"/>
          <a:stretch/>
        </p:blipFill>
        <p:spPr>
          <a:xfrm>
            <a:off x="2776713" y="1669828"/>
            <a:ext cx="2415323" cy="2150244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7"/>
          <a:srcRect l="4320" t="7136" b="7438"/>
          <a:stretch/>
        </p:blipFill>
        <p:spPr>
          <a:xfrm>
            <a:off x="5208244" y="1671958"/>
            <a:ext cx="2542673" cy="2148114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5808669" y="1310329"/>
            <a:ext cx="1610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TRA-1-85 APC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01648" y="2421784"/>
            <a:ext cx="1920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CA" dirty="0">
                <a:solidFill>
                  <a:prstClr val="black"/>
                </a:solidFill>
              </a:rPr>
              <a:t>R</a:t>
            </a:r>
            <a:r>
              <a:rPr lang="en-CA" dirty="0">
                <a:solidFill>
                  <a:prstClr val="black"/>
                </a:solidFill>
              </a:rPr>
              <a:t>at </a:t>
            </a:r>
            <a:r>
              <a:rPr lang="en-CA" dirty="0" err="1">
                <a:solidFill>
                  <a:prstClr val="black"/>
                </a:solidFill>
              </a:rPr>
              <a:t>cardiomyocyte</a:t>
            </a:r>
            <a:r>
              <a:rPr lang="en-CA" dirty="0">
                <a:solidFill>
                  <a:prstClr val="black"/>
                </a:solidFill>
              </a:rPr>
              <a:t> </a:t>
            </a:r>
          </a:p>
          <a:p>
            <a:pPr algn="r"/>
            <a:r>
              <a:rPr lang="en-CA" dirty="0">
                <a:solidFill>
                  <a:prstClr val="black"/>
                </a:solidFill>
              </a:rPr>
              <a:t>culture</a:t>
            </a:r>
            <a:endParaRPr lang="en-CA" dirty="0">
              <a:solidFill>
                <a:prstClr val="black"/>
              </a:solidFill>
            </a:endParaRPr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8"/>
          <a:srcRect l="5159" t="7348" b="6805"/>
          <a:stretch/>
        </p:blipFill>
        <p:spPr>
          <a:xfrm>
            <a:off x="7799379" y="1707971"/>
            <a:ext cx="2495525" cy="2158710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8367550" y="1314564"/>
            <a:ext cx="1481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TRA-1-85 FITC</a:t>
            </a:r>
            <a:endParaRPr lang="en-CA" dirty="0">
              <a:solidFill>
                <a:prstClr val="black"/>
              </a:solidFill>
            </a:endParaRP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7"/>
          <a:srcRect l="12457" t="6864" b="14211"/>
          <a:stretch/>
        </p:blipFill>
        <p:spPr>
          <a:xfrm rot="16200000" flipV="1">
            <a:off x="5618283" y="1524070"/>
            <a:ext cx="1969340" cy="229592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3454847" y="1310329"/>
            <a:ext cx="1610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Unstained</a:t>
            </a:r>
          </a:p>
        </p:txBody>
      </p:sp>
      <p:sp>
        <p:nvSpPr>
          <p:cNvPr id="8" name="Rectangle 7"/>
          <p:cNvSpPr/>
          <p:nvPr/>
        </p:nvSpPr>
        <p:spPr>
          <a:xfrm>
            <a:off x="5564450" y="3919437"/>
            <a:ext cx="788672" cy="6666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>
              <a:solidFill>
                <a:prstClr val="white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9198766" y="4915898"/>
            <a:ext cx="514187" cy="8237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>
              <a:solidFill>
                <a:prstClr val="white"/>
              </a:solidFill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 flipV="1">
            <a:off x="2644426" y="1743635"/>
            <a:ext cx="0" cy="40522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2993777" y="6243712"/>
            <a:ext cx="7301127" cy="304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353122" y="6243712"/>
            <a:ext cx="81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FITC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2060189" y="3472038"/>
            <a:ext cx="81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APC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8862646" y="4915898"/>
            <a:ext cx="289115" cy="8237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>
              <a:solidFill>
                <a:prstClr val="white"/>
              </a:solidFill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5576172" y="4620474"/>
            <a:ext cx="666521" cy="58710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>
              <a:solidFill>
                <a:prstClr val="white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515099" y="4544692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solidFill>
                  <a:prstClr val="black"/>
                </a:solidFill>
              </a:rPr>
              <a:t>L</a:t>
            </a:r>
            <a:endParaRPr lang="en-CA" b="1" dirty="0">
              <a:solidFill>
                <a:prstClr val="black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937765" y="5463022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solidFill>
                  <a:prstClr val="black"/>
                </a:solidFill>
              </a:rPr>
              <a:t>L</a:t>
            </a:r>
            <a:endParaRPr lang="en-CA" b="1" dirty="0">
              <a:solidFill>
                <a:prstClr val="black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503377" y="3838435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solidFill>
                  <a:prstClr val="black"/>
                </a:solidFill>
              </a:rPr>
              <a:t>H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9455288" y="5434777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solidFill>
                  <a:prstClr val="black"/>
                </a:solidFill>
              </a:rPr>
              <a:t>H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81732" y="240896"/>
            <a:ext cx="3103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>
                <a:solidFill>
                  <a:prstClr val="black"/>
                </a:solidFill>
              </a:rPr>
              <a:t>Supplementary Figure 1</a:t>
            </a:r>
            <a:endParaRPr lang="en-CA" dirty="0">
              <a:solidFill>
                <a:prstClr val="black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01648" y="1125663"/>
            <a:ext cx="427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solidFill>
                  <a:prstClr val="black"/>
                </a:solidFill>
              </a:rPr>
              <a:t>A</a:t>
            </a:r>
            <a:endParaRPr lang="en-CA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240143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47"/>
          <a:stretch/>
        </p:blipFill>
        <p:spPr>
          <a:xfrm>
            <a:off x="0" y="510746"/>
            <a:ext cx="12192000" cy="63472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9827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42</Words>
  <Application>Microsoft Office PowerPoint</Application>
  <PresentationFormat>Widescreen</PresentationFormat>
  <Paragraphs>2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1_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Szaraz</dc:creator>
  <cp:lastModifiedBy>Peter Szaraz</cp:lastModifiedBy>
  <cp:revision>5</cp:revision>
  <dcterms:created xsi:type="dcterms:W3CDTF">2016-02-12T19:57:45Z</dcterms:created>
  <dcterms:modified xsi:type="dcterms:W3CDTF">2016-02-12T20:02:39Z</dcterms:modified>
</cp:coreProperties>
</file>